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32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1638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786391745363498E-2"/>
          <c:y val="6.0938838553035002E-2"/>
          <c:w val="0.77745439278331596"/>
          <c:h val="0.706187742690724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ene features pie charts v2.xlsx]Piechart_data.xls'!$J$38</c:f>
              <c:strCache>
                <c:ptCount val="1"/>
                <c:pt idx="0">
                  <c:v>ChIP_Sox9</c:v>
                </c:pt>
              </c:strCache>
            </c:strRef>
          </c:tx>
          <c:invertIfNegative val="0"/>
          <c:cat>
            <c:strRef>
              <c:f>'[Gene features pie charts v2.xlsx]Piechart_data.xls'!$I$39:$I$51</c:f>
              <c:strCache>
                <c:ptCount val="13"/>
                <c:pt idx="0">
                  <c:v>DIST PROM (1-3 kb)</c:v>
                </c:pt>
                <c:pt idx="1">
                  <c:v>PROX PROM (0-1 kb)</c:v>
                </c:pt>
                <c:pt idx="2">
                  <c:v>GENEBODY</c:v>
                </c:pt>
                <c:pt idx="3">
                  <c:v>5`-UTR</c:v>
                </c:pt>
                <c:pt idx="4">
                  <c:v>EXON</c:v>
                </c:pt>
                <c:pt idx="5">
                  <c:v>INTRON</c:v>
                </c:pt>
                <c:pt idx="6">
                  <c:v>3`-UTR</c:v>
                </c:pt>
                <c:pt idx="7">
                  <c:v>PROX DOWNSTR (0-1 kb)</c:v>
                </c:pt>
                <c:pt idx="8">
                  <c:v>DIST DOWNSTR (1-3 kb)</c:v>
                </c:pt>
                <c:pt idx="9">
                  <c:v>DIST INTERGENIC</c:v>
                </c:pt>
                <c:pt idx="10">
                  <c:v>CpGI +/-200 bp</c:v>
                </c:pt>
                <c:pt idx="11">
                  <c:v>SIMPLE REPEATS</c:v>
                </c:pt>
                <c:pt idx="12">
                  <c:v>Repeat Masked</c:v>
                </c:pt>
              </c:strCache>
            </c:strRef>
          </c:cat>
          <c:val>
            <c:numRef>
              <c:f>'[Gene features pie charts v2.xlsx]Piechart_data.xls'!$J$39:$J$51</c:f>
              <c:numCache>
                <c:formatCode>0.00</c:formatCode>
                <c:ptCount val="13"/>
                <c:pt idx="0">
                  <c:v>1.2519405759502089</c:v>
                </c:pt>
                <c:pt idx="1">
                  <c:v>3.9876777706052415</c:v>
                </c:pt>
                <c:pt idx="2">
                  <c:v>-1.9046941785263408E-2</c:v>
                </c:pt>
                <c:pt idx="3">
                  <c:v>4.538647307808616</c:v>
                </c:pt>
                <c:pt idx="4">
                  <c:v>1.1101829177504232</c:v>
                </c:pt>
                <c:pt idx="5">
                  <c:v>-0.54398535649622803</c:v>
                </c:pt>
                <c:pt idx="6">
                  <c:v>0.53852692773087152</c:v>
                </c:pt>
                <c:pt idx="7">
                  <c:v>1.4728815738511283</c:v>
                </c:pt>
                <c:pt idx="8">
                  <c:v>1.3194313621484639</c:v>
                </c:pt>
                <c:pt idx="9">
                  <c:v>-0.86997273614371884</c:v>
                </c:pt>
                <c:pt idx="10">
                  <c:v>4.2770022240058463</c:v>
                </c:pt>
                <c:pt idx="11">
                  <c:v>6.1602249668440967E-2</c:v>
                </c:pt>
                <c:pt idx="12">
                  <c:v>-1.6603231072183451</c:v>
                </c:pt>
              </c:numCache>
            </c:numRef>
          </c:val>
        </c:ser>
        <c:ser>
          <c:idx val="1"/>
          <c:order val="1"/>
          <c:tx>
            <c:strRef>
              <c:f>'[Gene features pie charts v2.xlsx]Piechart_data.xls'!$K$38</c:f>
              <c:strCache>
                <c:ptCount val="1"/>
                <c:pt idx="0">
                  <c:v>BOTH_motifs</c:v>
                </c:pt>
              </c:strCache>
            </c:strRef>
          </c:tx>
          <c:invertIfNegative val="0"/>
          <c:cat>
            <c:strRef>
              <c:f>'[Gene features pie charts v2.xlsx]Piechart_data.xls'!$I$39:$I$51</c:f>
              <c:strCache>
                <c:ptCount val="13"/>
                <c:pt idx="0">
                  <c:v>DIST PROM (1-3 kb)</c:v>
                </c:pt>
                <c:pt idx="1">
                  <c:v>PROX PROM (0-1 kb)</c:v>
                </c:pt>
                <c:pt idx="2">
                  <c:v>GENEBODY</c:v>
                </c:pt>
                <c:pt idx="3">
                  <c:v>5`-UTR</c:v>
                </c:pt>
                <c:pt idx="4">
                  <c:v>EXON</c:v>
                </c:pt>
                <c:pt idx="5">
                  <c:v>INTRON</c:v>
                </c:pt>
                <c:pt idx="6">
                  <c:v>3`-UTR</c:v>
                </c:pt>
                <c:pt idx="7">
                  <c:v>PROX DOWNSTR (0-1 kb)</c:v>
                </c:pt>
                <c:pt idx="8">
                  <c:v>DIST DOWNSTR (1-3 kb)</c:v>
                </c:pt>
                <c:pt idx="9">
                  <c:v>DIST INTERGENIC</c:v>
                </c:pt>
                <c:pt idx="10">
                  <c:v>CpGI +/-200 bp</c:v>
                </c:pt>
                <c:pt idx="11">
                  <c:v>SIMPLE REPEATS</c:v>
                </c:pt>
                <c:pt idx="12">
                  <c:v>Repeat Masked</c:v>
                </c:pt>
              </c:strCache>
            </c:strRef>
          </c:cat>
          <c:val>
            <c:numRef>
              <c:f>'[Gene features pie charts v2.xlsx]Piechart_data.xls'!$K$39:$K$51</c:f>
              <c:numCache>
                <c:formatCode>0.00</c:formatCode>
                <c:ptCount val="13"/>
                <c:pt idx="0">
                  <c:v>1.4294465920991506</c:v>
                </c:pt>
                <c:pt idx="1">
                  <c:v>4.3820683168056442</c:v>
                </c:pt>
                <c:pt idx="2">
                  <c:v>-0.26768052360044309</c:v>
                </c:pt>
                <c:pt idx="3">
                  <c:v>4.3782410517390655</c:v>
                </c:pt>
                <c:pt idx="4">
                  <c:v>-0.38192139246507711</c:v>
                </c:pt>
                <c:pt idx="5">
                  <c:v>-0.7376668501389102</c:v>
                </c:pt>
                <c:pt idx="6">
                  <c:v>-0.19254402835659223</c:v>
                </c:pt>
                <c:pt idx="7">
                  <c:v>1.6311347603603694</c:v>
                </c:pt>
                <c:pt idx="8">
                  <c:v>1.3264916798988911</c:v>
                </c:pt>
                <c:pt idx="9">
                  <c:v>-0.95918436835533583</c:v>
                </c:pt>
                <c:pt idx="10">
                  <c:v>4.4043790623298538</c:v>
                </c:pt>
                <c:pt idx="11">
                  <c:v>-0.62380998942732246</c:v>
                </c:pt>
                <c:pt idx="12">
                  <c:v>-1.8503285343258524</c:v>
                </c:pt>
              </c:numCache>
            </c:numRef>
          </c:val>
        </c:ser>
        <c:ser>
          <c:idx val="2"/>
          <c:order val="2"/>
          <c:tx>
            <c:strRef>
              <c:f>'[Gene features pie charts v2.xlsx]Piechart_data.xls'!$L$38</c:f>
              <c:strCache>
                <c:ptCount val="1"/>
                <c:pt idx="0">
                  <c:v>Motif1_only</c:v>
                </c:pt>
              </c:strCache>
            </c:strRef>
          </c:tx>
          <c:invertIfNegative val="0"/>
          <c:cat>
            <c:strRef>
              <c:f>'[Gene features pie charts v2.xlsx]Piechart_data.xls'!$I$39:$I$51</c:f>
              <c:strCache>
                <c:ptCount val="13"/>
                <c:pt idx="0">
                  <c:v>DIST PROM (1-3 kb)</c:v>
                </c:pt>
                <c:pt idx="1">
                  <c:v>PROX PROM (0-1 kb)</c:v>
                </c:pt>
                <c:pt idx="2">
                  <c:v>GENEBODY</c:v>
                </c:pt>
                <c:pt idx="3">
                  <c:v>5`-UTR</c:v>
                </c:pt>
                <c:pt idx="4">
                  <c:v>EXON</c:v>
                </c:pt>
                <c:pt idx="5">
                  <c:v>INTRON</c:v>
                </c:pt>
                <c:pt idx="6">
                  <c:v>3`-UTR</c:v>
                </c:pt>
                <c:pt idx="7">
                  <c:v>PROX DOWNSTR (0-1 kb)</c:v>
                </c:pt>
                <c:pt idx="8">
                  <c:v>DIST DOWNSTR (1-3 kb)</c:v>
                </c:pt>
                <c:pt idx="9">
                  <c:v>DIST INTERGENIC</c:v>
                </c:pt>
                <c:pt idx="10">
                  <c:v>CpGI +/-200 bp</c:v>
                </c:pt>
                <c:pt idx="11">
                  <c:v>SIMPLE REPEATS</c:v>
                </c:pt>
                <c:pt idx="12">
                  <c:v>Repeat Masked</c:v>
                </c:pt>
              </c:strCache>
            </c:strRef>
          </c:cat>
          <c:val>
            <c:numRef>
              <c:f>'[Gene features pie charts v2.xlsx]Piechart_data.xls'!$L$39:$L$51</c:f>
              <c:numCache>
                <c:formatCode>0.00</c:formatCode>
                <c:ptCount val="13"/>
                <c:pt idx="0">
                  <c:v>1.5678093232122745</c:v>
                </c:pt>
                <c:pt idx="1">
                  <c:v>4.9318472749644586</c:v>
                </c:pt>
                <c:pt idx="2">
                  <c:v>-0.32316738348204366</c:v>
                </c:pt>
                <c:pt idx="3">
                  <c:v>4.9804404173263208</c:v>
                </c:pt>
                <c:pt idx="4">
                  <c:v>0.7764790918845923</c:v>
                </c:pt>
                <c:pt idx="5">
                  <c:v>-1.324827781605497</c:v>
                </c:pt>
                <c:pt idx="6">
                  <c:v>0.56730707950280224</c:v>
                </c:pt>
                <c:pt idx="7">
                  <c:v>1.7389091716400706</c:v>
                </c:pt>
                <c:pt idx="8">
                  <c:v>1.8233083819244915</c:v>
                </c:pt>
                <c:pt idx="9">
                  <c:v>-1.9543434794190844</c:v>
                </c:pt>
                <c:pt idx="10">
                  <c:v>4.987238356558338</c:v>
                </c:pt>
                <c:pt idx="11">
                  <c:v>-0.46540950507765289</c:v>
                </c:pt>
                <c:pt idx="12">
                  <c:v>-2.5136129158807647</c:v>
                </c:pt>
              </c:numCache>
            </c:numRef>
          </c:val>
        </c:ser>
        <c:ser>
          <c:idx val="3"/>
          <c:order val="3"/>
          <c:tx>
            <c:strRef>
              <c:f>'[Gene features pie charts v2.xlsx]Piechart_data.xls'!$M$38</c:f>
              <c:strCache>
                <c:ptCount val="1"/>
                <c:pt idx="0">
                  <c:v>Motif2-3_only</c:v>
                </c:pt>
              </c:strCache>
            </c:strRef>
          </c:tx>
          <c:invertIfNegative val="0"/>
          <c:cat>
            <c:strRef>
              <c:f>'[Gene features pie charts v2.xlsx]Piechart_data.xls'!$I$39:$I$51</c:f>
              <c:strCache>
                <c:ptCount val="13"/>
                <c:pt idx="0">
                  <c:v>DIST PROM (1-3 kb)</c:v>
                </c:pt>
                <c:pt idx="1">
                  <c:v>PROX PROM (0-1 kb)</c:v>
                </c:pt>
                <c:pt idx="2">
                  <c:v>GENEBODY</c:v>
                </c:pt>
                <c:pt idx="3">
                  <c:v>5`-UTR</c:v>
                </c:pt>
                <c:pt idx="4">
                  <c:v>EXON</c:v>
                </c:pt>
                <c:pt idx="5">
                  <c:v>INTRON</c:v>
                </c:pt>
                <c:pt idx="6">
                  <c:v>3`-UTR</c:v>
                </c:pt>
                <c:pt idx="7">
                  <c:v>PROX DOWNSTR (0-1 kb)</c:v>
                </c:pt>
                <c:pt idx="8">
                  <c:v>DIST DOWNSTR (1-3 kb)</c:v>
                </c:pt>
                <c:pt idx="9">
                  <c:v>DIST INTERGENIC</c:v>
                </c:pt>
                <c:pt idx="10">
                  <c:v>CpGI +/-200 bp</c:v>
                </c:pt>
                <c:pt idx="11">
                  <c:v>SIMPLE REPEATS</c:v>
                </c:pt>
                <c:pt idx="12">
                  <c:v>Repeat Masked</c:v>
                </c:pt>
              </c:strCache>
            </c:strRef>
          </c:cat>
          <c:val>
            <c:numRef>
              <c:f>'[Gene features pie charts v2.xlsx]Piechart_data.xls'!$M$39:$M$51</c:f>
              <c:numCache>
                <c:formatCode>0.00</c:formatCode>
                <c:ptCount val="13"/>
                <c:pt idx="0">
                  <c:v>0.75105021855316201</c:v>
                </c:pt>
                <c:pt idx="1">
                  <c:v>3.0134974028838264</c:v>
                </c:pt>
                <c:pt idx="2">
                  <c:v>2.2204197377838807E-2</c:v>
                </c:pt>
                <c:pt idx="3">
                  <c:v>3.7990417641405867</c:v>
                </c:pt>
                <c:pt idx="4">
                  <c:v>0.33999822756101322</c:v>
                </c:pt>
                <c:pt idx="5">
                  <c:v>-0.22717988911712331</c:v>
                </c:pt>
                <c:pt idx="6">
                  <c:v>0.48714735628020051</c:v>
                </c:pt>
                <c:pt idx="7">
                  <c:v>1.018700543450948</c:v>
                </c:pt>
                <c:pt idx="8">
                  <c:v>0.85752667984702224</c:v>
                </c:pt>
                <c:pt idx="9">
                  <c:v>-0.38993252505759873</c:v>
                </c:pt>
                <c:pt idx="10">
                  <c:v>3.3646514093230362</c:v>
                </c:pt>
                <c:pt idx="11">
                  <c:v>-0.47304707059735801</c:v>
                </c:pt>
                <c:pt idx="12">
                  <c:v>-1.3532184539376166</c:v>
                </c:pt>
              </c:numCache>
            </c:numRef>
          </c:val>
        </c:ser>
        <c:ser>
          <c:idx val="4"/>
          <c:order val="4"/>
          <c:tx>
            <c:strRef>
              <c:f>'[Gene features pie charts v2.xlsx]Piechart_data.xls'!$N$38</c:f>
              <c:strCache>
                <c:ptCount val="1"/>
                <c:pt idx="0">
                  <c:v>NO_motifs</c:v>
                </c:pt>
              </c:strCache>
            </c:strRef>
          </c:tx>
          <c:invertIfNegative val="0"/>
          <c:cat>
            <c:strRef>
              <c:f>'[Gene features pie charts v2.xlsx]Piechart_data.xls'!$I$39:$I$51</c:f>
              <c:strCache>
                <c:ptCount val="13"/>
                <c:pt idx="0">
                  <c:v>DIST PROM (1-3 kb)</c:v>
                </c:pt>
                <c:pt idx="1">
                  <c:v>PROX PROM (0-1 kb)</c:v>
                </c:pt>
                <c:pt idx="2">
                  <c:v>GENEBODY</c:v>
                </c:pt>
                <c:pt idx="3">
                  <c:v>5`-UTR</c:v>
                </c:pt>
                <c:pt idx="4">
                  <c:v>EXON</c:v>
                </c:pt>
                <c:pt idx="5">
                  <c:v>INTRON</c:v>
                </c:pt>
                <c:pt idx="6">
                  <c:v>3`-UTR</c:v>
                </c:pt>
                <c:pt idx="7">
                  <c:v>PROX DOWNSTR (0-1 kb)</c:v>
                </c:pt>
                <c:pt idx="8">
                  <c:v>DIST DOWNSTR (1-3 kb)</c:v>
                </c:pt>
                <c:pt idx="9">
                  <c:v>DIST INTERGENIC</c:v>
                </c:pt>
                <c:pt idx="10">
                  <c:v>CpGI +/-200 bp</c:v>
                </c:pt>
                <c:pt idx="11">
                  <c:v>SIMPLE REPEATS</c:v>
                </c:pt>
                <c:pt idx="12">
                  <c:v>Repeat Masked</c:v>
                </c:pt>
              </c:strCache>
            </c:strRef>
          </c:cat>
          <c:val>
            <c:numRef>
              <c:f>'[Gene features pie charts v2.xlsx]Piechart_data.xls'!$N$39:$N$51</c:f>
              <c:numCache>
                <c:formatCode>0.00</c:formatCode>
                <c:ptCount val="13"/>
                <c:pt idx="0">
                  <c:v>1.4079028357801509</c:v>
                </c:pt>
                <c:pt idx="1">
                  <c:v>4.0279202723320413</c:v>
                </c:pt>
                <c:pt idx="2">
                  <c:v>6.3759948289541388E-2</c:v>
                </c:pt>
                <c:pt idx="3">
                  <c:v>4.7936347065305087</c:v>
                </c:pt>
                <c:pt idx="4">
                  <c:v>1.6443633763065388</c:v>
                </c:pt>
                <c:pt idx="5">
                  <c:v>-0.59029392208196063</c:v>
                </c:pt>
                <c:pt idx="6">
                  <c:v>0.65002878724263535</c:v>
                </c:pt>
                <c:pt idx="7">
                  <c:v>1.6265768928115698</c:v>
                </c:pt>
                <c:pt idx="8">
                  <c:v>1.4175127058979062</c:v>
                </c:pt>
                <c:pt idx="9">
                  <c:v>-1.0455469139846429</c:v>
                </c:pt>
                <c:pt idx="10">
                  <c:v>4.4533077600029856</c:v>
                </c:pt>
                <c:pt idx="11">
                  <c:v>0.50826944336689006</c:v>
                </c:pt>
                <c:pt idx="12">
                  <c:v>-1.68766662350304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6278016"/>
        <c:axId val="96279552"/>
      </c:barChart>
      <c:catAx>
        <c:axId val="96278016"/>
        <c:scaling>
          <c:orientation val="minMax"/>
        </c:scaling>
        <c:delete val="0"/>
        <c:axPos val="b"/>
        <c:majorTickMark val="out"/>
        <c:minorTickMark val="none"/>
        <c:tickLblPos val="nextTo"/>
        <c:crossAx val="96279552"/>
        <c:crosses val="autoZero"/>
        <c:auto val="1"/>
        <c:lblAlgn val="ctr"/>
        <c:lblOffset val="100"/>
        <c:noMultiLvlLbl val="0"/>
      </c:catAx>
      <c:valAx>
        <c:axId val="9627955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9627801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9.1031252429754086E-2"/>
          <c:y val="0"/>
          <c:w val="0.72617411608000459"/>
          <c:h val="4.6065877054558418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7D4DD6-878A-4260-A1E7-ACE1E5C6D78E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5736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3/9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9986863"/>
              </p:ext>
            </p:extLst>
          </p:nvPr>
        </p:nvGraphicFramePr>
        <p:xfrm>
          <a:off x="1133872" y="1066800"/>
          <a:ext cx="6366385" cy="49853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329333" y="6131958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5806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50</TotalTime>
  <Words>4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Shi, Zhongcheng</cp:lastModifiedBy>
  <cp:revision>1580</cp:revision>
  <cp:lastPrinted>2014-02-08T00:35:07Z</cp:lastPrinted>
  <dcterms:created xsi:type="dcterms:W3CDTF">2013-01-30T00:52:15Z</dcterms:created>
  <dcterms:modified xsi:type="dcterms:W3CDTF">2015-03-09T16:26:10Z</dcterms:modified>
</cp:coreProperties>
</file>